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0"/>
    <p:restoredTop sz="95728"/>
  </p:normalViewPr>
  <p:slideViewPr>
    <p:cSldViewPr snapToGrid="0">
      <p:cViewPr varScale="1">
        <p:scale>
          <a:sx n="103" d="100"/>
          <a:sy n="103" d="100"/>
        </p:scale>
        <p:origin x="89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63F5780-CBDC-F04E-87D7-292B516C5781}" type="datetimeFigureOut">
              <a:rPr lang="fr-FR" smtClean="0"/>
              <a:t>21/06/2025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83886ED-C269-D84C-AB8D-FCC744DE2C4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242361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4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Google Shape;44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5" name="Google Shape;45;p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46" name="Google Shape;46;p2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Calibri"/>
              <a:buNone/>
            </a:pPr>
            <a:fld id="{00000000-1234-1234-1234-123412341234}" type="slidenum">
              <a:rPr lang="en-US" sz="1200" b="0" i="0" u="none" strike="noStrike" cap="none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1</a:t>
            </a:fld>
            <a:endParaRPr sz="1200" b="0" i="0" u="none" strike="noStrike" cap="none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5EC2EB0-A431-5B4B-F8A0-BBE54A5A143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99CF93BF-4003-EC84-C611-259729094A6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65EB2A6-E936-6B2C-F7F3-92120986CD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FA067-2F3B-B945-8CF0-879B77E5EF90}" type="datetimeFigureOut">
              <a:rPr lang="fr-FR" smtClean="0"/>
              <a:t>21/06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57B5314-7D7C-A412-250D-C7636338D3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EA8F4FA-3DF8-3CD4-E9B2-2CE760A1F8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B8C48-198F-144B-AE16-E93CCF1885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721055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31B3CD6-4598-ACCD-EE47-3635609791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7D7DF94C-6224-ECF9-3661-D36829B169F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20320CC-6F6C-7F9E-67D8-1438ACA2E5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FA067-2F3B-B945-8CF0-879B77E5EF90}" type="datetimeFigureOut">
              <a:rPr lang="fr-FR" smtClean="0"/>
              <a:t>21/06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0D88A2C-3E0E-5AC7-DD22-7CF3D8C6EF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EE065EB-B2F1-0456-7D41-323006E051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B8C48-198F-144B-AE16-E93CCF1885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117469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73B304B0-3AC8-FD55-90C5-2E4F4AB8EDA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E38EE9C8-E776-E347-5360-25BD22A21D3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E88FE63-4C03-929B-3E0F-077D546867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FA067-2F3B-B945-8CF0-879B77E5EF90}" type="datetimeFigureOut">
              <a:rPr lang="fr-FR" smtClean="0"/>
              <a:t>21/06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D594A56-0423-AEBA-E970-EAA5E1C215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F6BE3B1-4867-1613-2094-2BCB43F02A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B8C48-198F-144B-AE16-E93CCF1885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842368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8C71627-D37A-BA97-CADB-10A0141CCC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EF4DC823-355F-9CCB-CFB7-11F4F23C1C9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0762C53-DB74-6069-9BDE-FE4CA39053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FA067-2F3B-B945-8CF0-879B77E5EF90}" type="datetimeFigureOut">
              <a:rPr lang="fr-FR" smtClean="0"/>
              <a:t>21/06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D47C036-5A8C-D06A-0508-40B1666220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3704661-18A1-31D5-E9DD-0B4978DDC2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B8C48-198F-144B-AE16-E93CCF1885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075488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064DD06-D07E-CF4B-C6FA-6175FA1AE8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875822E4-102B-61FE-2961-C5E3EB0BCC8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CA53B6C-816F-383A-D3FD-300F61EF10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FA067-2F3B-B945-8CF0-879B77E5EF90}" type="datetimeFigureOut">
              <a:rPr lang="fr-FR" smtClean="0"/>
              <a:t>21/06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E8AFA0A1-F4D3-A588-0321-5EECC02A36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C6C0530-F002-15B7-6092-C8E534EAEB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B8C48-198F-144B-AE16-E93CCF1885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347639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1ACEEBE-2A4E-B5BF-41E8-BB62227049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063D30CA-71E6-B409-DBE7-873DE605972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134A9CF3-C877-D441-6B30-387D3143E6C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18048402-504C-220D-881D-9CB428E403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FA067-2F3B-B945-8CF0-879B77E5EF90}" type="datetimeFigureOut">
              <a:rPr lang="fr-FR" smtClean="0"/>
              <a:t>21/06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F46D629B-914E-41A7-BB8C-8F2EDE29D3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4CABC357-3D2C-7CF0-AE71-A39F618E55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B8C48-198F-144B-AE16-E93CCF1885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185477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61EB950-DC3F-A668-AFA8-4A1F6DF2FD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5B5DC6AD-A9DF-5AEE-B43D-B95F09F6E2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C15BD59B-C194-4EB5-E314-46673483F2E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06B497D2-0813-334D-09E4-68E4CBA9FD7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3C0F6072-8204-3EB7-A476-8C96A80DAE8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F059EC11-2FE1-853B-6705-55A9D5A3D7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FA067-2F3B-B945-8CF0-879B77E5EF90}" type="datetimeFigureOut">
              <a:rPr lang="fr-FR" smtClean="0"/>
              <a:t>21/06/2025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41F9A5D0-F2EB-108F-E122-5DF1D8A143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0FDD516D-E118-C866-E2F0-098DEE74F5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B8C48-198F-144B-AE16-E93CCF1885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87218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46C8078-0A68-1D20-97DF-FE58DA6580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66B72973-9CF5-0435-8042-781BB1FF7F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FA067-2F3B-B945-8CF0-879B77E5EF90}" type="datetimeFigureOut">
              <a:rPr lang="fr-FR" smtClean="0"/>
              <a:t>21/06/2025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718412CA-5DAB-5AE8-172F-B1DE4688C2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5FD30A72-C4A4-96C7-91D2-C822F03E60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B8C48-198F-144B-AE16-E93CCF1885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737128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781395B3-F0F6-160D-6A28-D60FCAA662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FA067-2F3B-B945-8CF0-879B77E5EF90}" type="datetimeFigureOut">
              <a:rPr lang="fr-FR" smtClean="0"/>
              <a:t>21/06/2025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F7900830-A5C4-9C54-8DBF-B7424A30C0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17A7BFB4-2252-C8A6-3C01-AB8FADB962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B8C48-198F-144B-AE16-E93CCF1885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595088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81534DB-FB19-75B8-3498-71332DF1F9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D9162FA7-D193-093D-44AC-22D06206126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AFB91276-27FA-65D6-1300-C109752812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81ED3476-6F03-42C7-CE94-ADA5C21C54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FA067-2F3B-B945-8CF0-879B77E5EF90}" type="datetimeFigureOut">
              <a:rPr lang="fr-FR" smtClean="0"/>
              <a:t>21/06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433822FF-6ED8-E985-EA89-F596D828F6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2F442408-C962-D0C9-9310-8B6AE8BAC9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B8C48-198F-144B-AE16-E93CCF1885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126709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931378C-F608-9761-3CC6-6BF8C99918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E237A14F-0290-2F5F-21D3-A8EAE31151D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35F89827-4750-44ED-6C12-42A5D90108B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9A207E4-FA93-336D-44C5-FDA04A17CF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FA067-2F3B-B945-8CF0-879B77E5EF90}" type="datetimeFigureOut">
              <a:rPr lang="fr-FR" smtClean="0"/>
              <a:t>21/06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3DD3B61F-CCA7-1D44-4FA6-E0010F2C89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30155972-4F0F-7AF4-648F-571D73F6D5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B8C48-198F-144B-AE16-E93CCF1885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208630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00DCDD59-844A-E4E7-A2EB-FE330C8EB6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05EA97C3-D178-8BEC-06B0-772F840FF8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272AF17-C3F0-A43E-680B-4B968DA4322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2FA067-2F3B-B945-8CF0-879B77E5EF90}" type="datetimeFigureOut">
              <a:rPr lang="fr-FR" smtClean="0"/>
              <a:t>21/06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3186320-7373-CF89-04E8-C195A361C32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CC24D52-0E5F-AFE3-265C-699F46C5BE5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4B8C48-198F-144B-AE16-E93CCF1885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007242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f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4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2"/>
          <p:cNvSpPr/>
          <p:nvPr/>
        </p:nvSpPr>
        <p:spPr>
          <a:xfrm>
            <a:off x="10072039" y="717656"/>
            <a:ext cx="184731" cy="46166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400"/>
              <a:buFont typeface="Arial"/>
              <a:buNone/>
            </a:pPr>
            <a:endParaRPr sz="2400" b="1" i="0" u="none" strike="noStrike" cap="none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52" name="Google Shape;52;p2"/>
          <p:cNvSpPr/>
          <p:nvPr/>
        </p:nvSpPr>
        <p:spPr>
          <a:xfrm>
            <a:off x="9040454" y="4981975"/>
            <a:ext cx="1216316" cy="161925"/>
          </a:xfrm>
          <a:prstGeom prst="rect">
            <a:avLst/>
          </a:prstGeom>
          <a:solidFill>
            <a:schemeClr val="lt1"/>
          </a:solidFill>
          <a:ln w="12700" cap="flat" cmpd="sng">
            <a:solidFill>
              <a:schemeClr val="lt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800"/>
              <a:buFont typeface="Arial"/>
              <a:buNone/>
            </a:pPr>
            <a:endParaRPr sz="1800" b="0" i="0" u="none" strike="noStrike" cap="none">
              <a:solidFill>
                <a:srgbClr val="FFFFFF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3" name="Image 2" descr="Une image contenant noir, obscurité&#10;&#10;Description générée automatiquement">
            <a:extLst>
              <a:ext uri="{FF2B5EF4-FFF2-40B4-BE49-F238E27FC236}">
                <a16:creationId xmlns:a16="http://schemas.microsoft.com/office/drawing/2014/main" id="{A70F753A-F948-0890-F23E-3F99F5F103C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8747" y="1633922"/>
            <a:ext cx="4536388" cy="2987091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A983C571-EEF1-E024-8ED1-A16F71C65549}"/>
              </a:ext>
            </a:extLst>
          </p:cNvPr>
          <p:cNvSpPr/>
          <p:nvPr/>
        </p:nvSpPr>
        <p:spPr>
          <a:xfrm>
            <a:off x="0" y="0"/>
            <a:ext cx="12192000" cy="827903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lnSpc>
                <a:spcPct val="200000"/>
              </a:lnSpc>
              <a:spcAft>
                <a:spcPts val="1000"/>
              </a:spcAft>
            </a:pPr>
            <a:r>
              <a:rPr lang="en-US" sz="2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schemia-reperfusion injury model with Porcine Whole-Blood Ex-Vivo Lung Perfusion</a:t>
            </a:r>
            <a:endParaRPr lang="fr-FR" sz="24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/>
            <a:endParaRPr lang="fr-FR" dirty="0"/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A96FC7B9-0011-9B88-6E60-41EA1E845101}"/>
              </a:ext>
            </a:extLst>
          </p:cNvPr>
          <p:cNvSpPr/>
          <p:nvPr/>
        </p:nvSpPr>
        <p:spPr>
          <a:xfrm>
            <a:off x="0" y="836768"/>
            <a:ext cx="12192000" cy="47399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5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bjective </a:t>
            </a:r>
            <a:r>
              <a:rPr lang="en-US" sz="1500" dirty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Reproduce lung graft dysfunction by perfusing ex-vivo porcine lungs with whole blood and modulate its severity with duration of cold ischemia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42B02C90-D455-2CA6-266C-5F0359835A02}"/>
              </a:ext>
            </a:extLst>
          </p:cNvPr>
          <p:cNvSpPr/>
          <p:nvPr/>
        </p:nvSpPr>
        <p:spPr>
          <a:xfrm>
            <a:off x="0" y="5018611"/>
            <a:ext cx="12192000" cy="710454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pPr algn="ctr"/>
            <a:r>
              <a:rPr lang="en-US" sz="20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fter 18 hours of cold ischemia time, ex-vivo whole blood perfusion for 6 hours replicated feature of severe ischemia-reperfusion injuries</a:t>
            </a:r>
            <a:endParaRPr lang="en-US" sz="20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/>
            <a:endParaRPr lang="en-US" dirty="0"/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0750CA58-EE8A-D97D-A277-7929E257EB3E}"/>
              </a:ext>
            </a:extLst>
          </p:cNvPr>
          <p:cNvSpPr txBox="1"/>
          <p:nvPr/>
        </p:nvSpPr>
        <p:spPr>
          <a:xfrm>
            <a:off x="1532238" y="1310757"/>
            <a:ext cx="238485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5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perimental protocol 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80A2B4FC-4EB2-E74F-0699-1FC0E531AC35}"/>
              </a:ext>
            </a:extLst>
          </p:cNvPr>
          <p:cNvSpPr/>
          <p:nvPr/>
        </p:nvSpPr>
        <p:spPr>
          <a:xfrm>
            <a:off x="5029201" y="1181388"/>
            <a:ext cx="7169336" cy="126014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just"/>
            <a:r>
              <a:rPr lang="en-US" sz="15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sults </a:t>
            </a:r>
            <a:r>
              <a:rPr lang="en-US" sz="1500" dirty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Perfusion with warm blood led to a significant increase in pulmonary vascular resistance. At the same time, there was a decrease in circulating neutrophils and an increase in pro-inflammatory cytokines in the blood. Histological analysis revealed that circulating inflammatory cells were sequestered in the lung tissue, causing </a:t>
            </a:r>
            <a:r>
              <a:rPr lang="en-US" sz="1500" dirty="0" err="1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icrovasculopathy</a:t>
            </a:r>
            <a:r>
              <a:rPr lang="en-US" sz="1500" dirty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which explained the observed vascular resistance profile</a:t>
            </a:r>
          </a:p>
        </p:txBody>
      </p:sp>
      <p:pic>
        <p:nvPicPr>
          <p:cNvPr id="12" name="Image 11" descr="Une image contenant capture d’écran, ligne, diagramme, conception&#10;&#10;Description générée automatiquement">
            <a:extLst>
              <a:ext uri="{FF2B5EF4-FFF2-40B4-BE49-F238E27FC236}">
                <a16:creationId xmlns:a16="http://schemas.microsoft.com/office/drawing/2014/main" id="{891636B1-467F-3DB0-4510-0129CDB851D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138701" y="2367443"/>
            <a:ext cx="1914598" cy="1431178"/>
          </a:xfrm>
          <a:prstGeom prst="rect">
            <a:avLst/>
          </a:prstGeom>
        </p:spPr>
      </p:pic>
      <p:pic>
        <p:nvPicPr>
          <p:cNvPr id="14" name="Image 13" descr="Une image contenant ligne, capture d’écran, obscurité&#10;&#10;Description générée automatiquement">
            <a:extLst>
              <a:ext uri="{FF2B5EF4-FFF2-40B4-BE49-F238E27FC236}">
                <a16:creationId xmlns:a16="http://schemas.microsoft.com/office/drawing/2014/main" id="{CBFD391F-9985-300C-BA48-68DBBF93D38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711318" y="2362887"/>
            <a:ext cx="1914599" cy="1431179"/>
          </a:xfrm>
          <a:prstGeom prst="rect">
            <a:avLst/>
          </a:prstGeom>
        </p:spPr>
      </p:pic>
      <p:pic>
        <p:nvPicPr>
          <p:cNvPr id="16" name="Image 15" descr="Une image contenant ligne, capture d’écran, obscurité, léger&#10;&#10;Description générée automatiquement">
            <a:extLst>
              <a:ext uri="{FF2B5EF4-FFF2-40B4-BE49-F238E27FC236}">
                <a16:creationId xmlns:a16="http://schemas.microsoft.com/office/drawing/2014/main" id="{775994BA-58F4-CAF2-66DC-E6390650C32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391065" y="3563853"/>
            <a:ext cx="1791645" cy="1418122"/>
          </a:xfrm>
          <a:prstGeom prst="rect">
            <a:avLst/>
          </a:prstGeom>
        </p:spPr>
      </p:pic>
      <p:pic>
        <p:nvPicPr>
          <p:cNvPr id="18" name="Image 17" descr="Une image contenant violet, Magenta, rose&#10;&#10;Description générée automatiquement">
            <a:extLst>
              <a:ext uri="{FF2B5EF4-FFF2-40B4-BE49-F238E27FC236}">
                <a16:creationId xmlns:a16="http://schemas.microsoft.com/office/drawing/2014/main" id="{A1B0A5F7-4E37-F7D4-79CC-384EA828DDE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9607565" y="3643335"/>
            <a:ext cx="2083076" cy="1231788"/>
          </a:xfrm>
          <a:prstGeom prst="rect">
            <a:avLst/>
          </a:prstGeom>
        </p:spPr>
      </p:pic>
      <p:pic>
        <p:nvPicPr>
          <p:cNvPr id="20" name="Image 19" descr="Une image contenant Police, symbole, texte, logo&#10;&#10;Description générée automatiquement">
            <a:extLst>
              <a:ext uri="{FF2B5EF4-FFF2-40B4-BE49-F238E27FC236}">
                <a16:creationId xmlns:a16="http://schemas.microsoft.com/office/drawing/2014/main" id="{653333E3-F2BE-63DE-27F6-5DFDACCF06E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0072039" y="2579068"/>
            <a:ext cx="1187957" cy="204066"/>
          </a:xfrm>
          <a:prstGeom prst="rect">
            <a:avLst/>
          </a:prstGeom>
        </p:spPr>
      </p:pic>
      <p:pic>
        <p:nvPicPr>
          <p:cNvPr id="22" name="Image 21" descr="Une image contenant Police, symbole, logo, blanc&#10;&#10;Description générée automatiquement">
            <a:extLst>
              <a:ext uri="{FF2B5EF4-FFF2-40B4-BE49-F238E27FC236}">
                <a16:creationId xmlns:a16="http://schemas.microsoft.com/office/drawing/2014/main" id="{C44EA837-5B6E-E43D-DC6C-7ABEF335A746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0072040" y="2838275"/>
            <a:ext cx="1091934" cy="204066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6</Words>
  <Application>Microsoft Macintosh PowerPoint</Application>
  <PresentationFormat>Grand écran</PresentationFormat>
  <Paragraphs>6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icrosoft Office User</dc:creator>
  <cp:lastModifiedBy>Microsoft Office User</cp:lastModifiedBy>
  <cp:revision>1</cp:revision>
  <dcterms:created xsi:type="dcterms:W3CDTF">2025-06-21T18:55:58Z</dcterms:created>
  <dcterms:modified xsi:type="dcterms:W3CDTF">2025-06-21T18:56:44Z</dcterms:modified>
</cp:coreProperties>
</file>